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94568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125" y="-5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031DD4-A78B-4B16-8C6F-C8C2A3623C59}" type="datetimeFigureOut">
              <a:rPr lang="ko-KR" altLang="en-US" smtClean="0"/>
              <a:t>2021-01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8D351-01D2-4EAC-AEAB-6C85B91430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156305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031DD4-A78B-4B16-8C6F-C8C2A3623C59}" type="datetimeFigureOut">
              <a:rPr lang="ko-KR" altLang="en-US" smtClean="0"/>
              <a:t>2021-01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8D351-01D2-4EAC-AEAB-6C85B91430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762713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031DD4-A78B-4B16-8C6F-C8C2A3623C59}" type="datetimeFigureOut">
              <a:rPr lang="ko-KR" altLang="en-US" smtClean="0"/>
              <a:t>2021-01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8D351-01D2-4EAC-AEAB-6C85B91430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602209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031DD4-A78B-4B16-8C6F-C8C2A3623C59}" type="datetimeFigureOut">
              <a:rPr lang="ko-KR" altLang="en-US" smtClean="0"/>
              <a:t>2021-01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8D351-01D2-4EAC-AEAB-6C85B91430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156431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031DD4-A78B-4B16-8C6F-C8C2A3623C59}" type="datetimeFigureOut">
              <a:rPr lang="ko-KR" altLang="en-US" smtClean="0"/>
              <a:t>2021-01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8D351-01D2-4EAC-AEAB-6C85B91430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8908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031DD4-A78B-4B16-8C6F-C8C2A3623C59}" type="datetimeFigureOut">
              <a:rPr lang="ko-KR" altLang="en-US" smtClean="0"/>
              <a:t>2021-01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8D351-01D2-4EAC-AEAB-6C85B91430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521310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031DD4-A78B-4B16-8C6F-C8C2A3623C59}" type="datetimeFigureOut">
              <a:rPr lang="ko-KR" altLang="en-US" smtClean="0"/>
              <a:t>2021-01-2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8D351-01D2-4EAC-AEAB-6C85B91430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805435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031DD4-A78B-4B16-8C6F-C8C2A3623C59}" type="datetimeFigureOut">
              <a:rPr lang="ko-KR" altLang="en-US" smtClean="0"/>
              <a:t>2021-01-2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8D351-01D2-4EAC-AEAB-6C85B91430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173283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031DD4-A78B-4B16-8C6F-C8C2A3623C59}" type="datetimeFigureOut">
              <a:rPr lang="ko-KR" altLang="en-US" smtClean="0"/>
              <a:t>2021-01-2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8D351-01D2-4EAC-AEAB-6C85B91430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514415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031DD4-A78B-4B16-8C6F-C8C2A3623C59}" type="datetimeFigureOut">
              <a:rPr lang="ko-KR" altLang="en-US" smtClean="0"/>
              <a:t>2021-01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8D351-01D2-4EAC-AEAB-6C85B91430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602680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031DD4-A78B-4B16-8C6F-C8C2A3623C59}" type="datetimeFigureOut">
              <a:rPr lang="ko-KR" altLang="en-US" smtClean="0"/>
              <a:t>2021-01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8D351-01D2-4EAC-AEAB-6C85B91430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867760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031DD4-A78B-4B16-8C6F-C8C2A3623C59}" type="datetimeFigureOut">
              <a:rPr lang="ko-KR" altLang="en-US" smtClean="0"/>
              <a:t>2021-01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D8D351-01D2-4EAC-AEAB-6C85B91430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85905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그룹 6"/>
          <p:cNvGrpSpPr/>
          <p:nvPr/>
        </p:nvGrpSpPr>
        <p:grpSpPr>
          <a:xfrm>
            <a:off x="-91028" y="198368"/>
            <a:ext cx="9254867" cy="5582508"/>
            <a:chOff x="-91028" y="198368"/>
            <a:chExt cx="9254867" cy="5582508"/>
          </a:xfrm>
        </p:grpSpPr>
        <p:grpSp>
          <p:nvGrpSpPr>
            <p:cNvPr id="3" name="그룹 2"/>
            <p:cNvGrpSpPr/>
            <p:nvPr/>
          </p:nvGrpSpPr>
          <p:grpSpPr>
            <a:xfrm>
              <a:off x="-91028" y="198368"/>
              <a:ext cx="9254867" cy="5582508"/>
              <a:chOff x="-91028" y="198368"/>
              <a:chExt cx="9254867" cy="5582508"/>
            </a:xfrm>
          </p:grpSpPr>
          <p:pic>
            <p:nvPicPr>
              <p:cNvPr id="1031" name="Picture 7" descr="C:\Users\Chang-Hee Kim\Documents\김창희\Works\Study\Writing\Writing\Writing\2020 MD with DCPN_노해민\연구데이터\최은희 Rt MD_2017.04 PTA.jpg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213" y="509863"/>
                <a:ext cx="5514206" cy="2333548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32" name="Picture 8" descr="C:\Users\Chang-Hee Kim\Documents\김창희\Works\Study\Writing\Writing\Writing\2020 MD with DCPN_노해민\연구데이터\최은희 caloric.jpg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508104" y="626077"/>
                <a:ext cx="3601570" cy="212017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34" name="Picture 10" descr="C:\Users\Chang-Hee Kim\Documents\김창희\Works\Study\Writing\Writing\Writing\2020 MD with DCPN_노해민\연구데이터\최은희 Rt HL.jpg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39895" y="2934672"/>
                <a:ext cx="4334555" cy="2664296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35" name="Picture 11" descr="C:\Users\Chang-Hee Kim\Documents\김창희\Works\Study\Writing\Writing\Writing\2020 MD with DCPN_노해민\연구데이터\최은희 Lt HR.jpg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572000" y="2958040"/>
                <a:ext cx="4591839" cy="26312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3" name="TextBox 12"/>
              <p:cNvSpPr txBox="1"/>
              <p:nvPr/>
            </p:nvSpPr>
            <p:spPr>
              <a:xfrm>
                <a:off x="5305457" y="289223"/>
                <a:ext cx="356188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2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ko-KR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-91028" y="198368"/>
                <a:ext cx="356188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2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ko-KR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-47086" y="2852936"/>
                <a:ext cx="370614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2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ko-KR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4425976" y="2852936"/>
                <a:ext cx="370614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2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endParaRPr lang="ko-KR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" name="TextBox 1"/>
              <p:cNvSpPr txBox="1"/>
              <p:nvPr/>
            </p:nvSpPr>
            <p:spPr>
              <a:xfrm>
                <a:off x="-3416" y="522550"/>
                <a:ext cx="35779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5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B</a:t>
                </a:r>
                <a:endParaRPr lang="ko-KR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2849970" y="473910"/>
                <a:ext cx="35779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5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B</a:t>
                </a:r>
                <a:endParaRPr lang="ko-KR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253770" y="5517232"/>
                <a:ext cx="26000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5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ko-KR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3986208" y="5526960"/>
                <a:ext cx="439544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5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 s</a:t>
                </a:r>
                <a:endParaRPr lang="ko-KR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8524944" y="5517232"/>
                <a:ext cx="439544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5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 s</a:t>
                </a:r>
                <a:endParaRPr lang="ko-KR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4902856" y="5517232"/>
                <a:ext cx="26000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5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ko-KR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 rot="16200000">
                <a:off x="4084992" y="4309145"/>
                <a:ext cx="920445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5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Eye position</a:t>
                </a:r>
                <a:endParaRPr lang="ko-KR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 rot="16200000">
                <a:off x="-350320" y="4305347"/>
                <a:ext cx="920445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5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Eye position</a:t>
                </a:r>
                <a:endParaRPr lang="ko-KR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7" name="TextBox 26"/>
            <p:cNvSpPr txBox="1"/>
            <p:nvPr/>
          </p:nvSpPr>
          <p:spPr>
            <a:xfrm>
              <a:off x="938033" y="489908"/>
              <a:ext cx="994183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ight Ear - HL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3810609" y="433239"/>
              <a:ext cx="907621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eft Ear - HL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5801421" y="745654"/>
              <a:ext cx="1400967" cy="19236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6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ight Cool Peak SPV: 6 deg/s</a:t>
              </a:r>
              <a:endParaRPr lang="ko-KR" altLang="en-US" sz="6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7552903" y="745654"/>
              <a:ext cx="1400967" cy="19236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6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eft Warm Peak SPV: 26 deg/s</a:t>
              </a:r>
              <a:endParaRPr lang="ko-KR" altLang="en-US" sz="6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5796136" y="2300536"/>
              <a:ext cx="1400967" cy="19236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6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ight Warm Peak SPV: -7 deg/s</a:t>
              </a:r>
              <a:endParaRPr lang="ko-KR" altLang="en-US" sz="6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7553996" y="2300536"/>
              <a:ext cx="1400967" cy="19236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6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eft Cool Peak SPV: -19 deg/s</a:t>
              </a:r>
              <a:endParaRPr lang="ko-KR" altLang="en-US" sz="6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직사각형 32"/>
            <p:cNvSpPr/>
            <p:nvPr/>
          </p:nvSpPr>
          <p:spPr>
            <a:xfrm>
              <a:off x="5577446" y="827187"/>
              <a:ext cx="65149" cy="158417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4" name="직사각형 33"/>
            <p:cNvSpPr/>
            <p:nvPr/>
          </p:nvSpPr>
          <p:spPr>
            <a:xfrm>
              <a:off x="7327354" y="941487"/>
              <a:ext cx="65149" cy="158417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" name="직사각형 4"/>
            <p:cNvSpPr/>
            <p:nvPr/>
          </p:nvSpPr>
          <p:spPr>
            <a:xfrm>
              <a:off x="8100392" y="2603004"/>
              <a:ext cx="360040" cy="7200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7" name="직사각형 36"/>
            <p:cNvSpPr/>
            <p:nvPr/>
          </p:nvSpPr>
          <p:spPr>
            <a:xfrm>
              <a:off x="6372200" y="2617862"/>
              <a:ext cx="360040" cy="7200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6228184" y="2545854"/>
              <a:ext cx="57492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econds</a:t>
              </a:r>
              <a:endParaRPr lang="ko-KR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7975426" y="2545854"/>
              <a:ext cx="57492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econds</a:t>
              </a:r>
              <a:endParaRPr lang="ko-KR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 rot="16200000">
              <a:off x="5176929" y="1474859"/>
              <a:ext cx="84085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V, deg/s</a:t>
              </a:r>
              <a:endParaRPr lang="ko-KR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 rot="16200000">
              <a:off x="6949805" y="1454669"/>
              <a:ext cx="84085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V, deg/s</a:t>
              </a:r>
              <a:endParaRPr lang="ko-KR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5823770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6</TotalTime>
  <Words>62</Words>
  <Application>Microsoft Office PowerPoint</Application>
  <PresentationFormat>화면 슬라이드 쇼(4:3)</PresentationFormat>
  <Paragraphs>22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User</dc:creator>
  <cp:lastModifiedBy>Windows User</cp:lastModifiedBy>
  <cp:revision>8</cp:revision>
  <cp:lastPrinted>2020-12-09T07:13:39Z</cp:lastPrinted>
  <dcterms:created xsi:type="dcterms:W3CDTF">2020-12-09T06:50:09Z</dcterms:created>
  <dcterms:modified xsi:type="dcterms:W3CDTF">2021-01-25T06:44:56Z</dcterms:modified>
</cp:coreProperties>
</file>